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  <p:sldId id="334" r:id="rId3"/>
    <p:sldId id="338" r:id="rId4"/>
    <p:sldId id="339" r:id="rId5"/>
    <p:sldId id="340" r:id="rId6"/>
    <p:sldId id="336" r:id="rId7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33F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86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275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566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899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241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464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654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900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038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413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720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923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450E2-D00F-4F1C-A7DF-F88463B2C754}" type="datetimeFigureOut">
              <a:rPr lang="en-US" smtClean="0"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67E525-D1EF-416A-9354-1C7A1E733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645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Word_Document.docx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www.ebi.ac.uk/research/thornton/software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5">
            <a:extLst>
              <a:ext uri="{FF2B5EF4-FFF2-40B4-BE49-F238E27FC236}">
                <a16:creationId xmlns:a16="http://schemas.microsoft.com/office/drawing/2014/main" id="{3CAF4C4F-4BEA-B82C-524C-0CBFF21BE0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272072-07BF-69BC-13E9-F169A37DFAE3}"/>
              </a:ext>
            </a:extLst>
          </p:cNvPr>
          <p:cNvSpPr txBox="1"/>
          <p:nvPr/>
        </p:nvSpPr>
        <p:spPr>
          <a:xfrm>
            <a:off x="683784" y="228600"/>
            <a:ext cx="24821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Table 1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636EA5F6-9A3D-8844-414B-EC7630E0F8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6054008"/>
              </p:ext>
            </p:extLst>
          </p:nvPr>
        </p:nvGraphicFramePr>
        <p:xfrm>
          <a:off x="1044575" y="1082675"/>
          <a:ext cx="6588125" cy="3236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5969390" imgH="2928239" progId="Word.Document.12">
                  <p:embed/>
                </p:oleObj>
              </mc:Choice>
              <mc:Fallback>
                <p:oleObj name="Document" r:id="rId2" imgW="5969390" imgH="2928239" progId="Word.Document.12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636EA5F6-9A3D-8844-414B-EC7630E0F81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44575" y="1082675"/>
                        <a:ext cx="6588125" cy="3236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0CC3023B-4BD7-E501-9F2D-B6135627D789}"/>
              </a:ext>
            </a:extLst>
          </p:cNvPr>
          <p:cNvSpPr txBox="1"/>
          <p:nvPr/>
        </p:nvSpPr>
        <p:spPr>
          <a:xfrm>
            <a:off x="940200" y="3835846"/>
            <a:ext cx="601425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kern="0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DD PHRED scores (&gt;20 indicates deleterious; PHRED scale scores are normalized to all potential 9 billion single nucleotide human variants) and Revel scores (rare  missense variants &gt;0.5  are likely disease-causing) for each variant. The UCSC Genome Browser was used to obtain Revel scores and the </a:t>
            </a:r>
            <a:r>
              <a:rPr lang="en-US" sz="800" kern="0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rSite</a:t>
            </a:r>
            <a:r>
              <a:rPr lang="en-US" sz="800" kern="0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atabase (</a:t>
            </a:r>
            <a:r>
              <a:rPr lang="en-US" sz="800" u="sng" kern="0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www.ebi.ac.uk/research/thornton/software/</a:t>
            </a:r>
            <a:r>
              <a:rPr lang="en-US" sz="800" kern="0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as used to obtain CADD PHRED scores. The reference single nucleotide polymorphism (</a:t>
            </a:r>
            <a:r>
              <a:rPr lang="en-US" sz="800" kern="0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s</a:t>
            </a:r>
            <a:r>
              <a:rPr lang="en-US" sz="800" kern="0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D in </a:t>
            </a:r>
            <a:r>
              <a:rPr lang="en-US" sz="800" kern="0" dirty="0" err="1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bSNP</a:t>
            </a:r>
            <a:r>
              <a:rPr lang="en-US" sz="800" kern="0" dirty="0">
                <a:solidFill>
                  <a:srgbClr val="00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http://www.ncbi.nlm.nih.gov/SNP/) is a key resource identifier, which is widely used in human genetics and genomics studies.</a:t>
            </a:r>
            <a:endParaRPr lang="en-US" sz="800" i="1" dirty="0">
              <a:latin typeface="Georgia" panose="020405020504050203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12581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2E1C244-6C48-B751-7911-6328567CDE5A}"/>
              </a:ext>
            </a:extLst>
          </p:cNvPr>
          <p:cNvSpPr txBox="1"/>
          <p:nvPr/>
        </p:nvSpPr>
        <p:spPr>
          <a:xfrm>
            <a:off x="226646" y="117145"/>
            <a:ext cx="2680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11F310-AC42-D837-4F76-CF68753DD1E2}"/>
              </a:ext>
            </a:extLst>
          </p:cNvPr>
          <p:cNvSpPr txBox="1"/>
          <p:nvPr/>
        </p:nvSpPr>
        <p:spPr>
          <a:xfrm>
            <a:off x="343246" y="1216115"/>
            <a:ext cx="5175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96625F0-ADF3-7CDF-BF5F-0FFEB65AB0DE}"/>
              </a:ext>
            </a:extLst>
          </p:cNvPr>
          <p:cNvSpPr txBox="1"/>
          <p:nvPr/>
        </p:nvSpPr>
        <p:spPr>
          <a:xfrm>
            <a:off x="4827917" y="1216115"/>
            <a:ext cx="5175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0BCECCB-AE6C-23C9-5390-C3F54D625F53}"/>
              </a:ext>
            </a:extLst>
          </p:cNvPr>
          <p:cNvSpPr txBox="1"/>
          <p:nvPr/>
        </p:nvSpPr>
        <p:spPr>
          <a:xfrm>
            <a:off x="2018581" y="2527540"/>
            <a:ext cx="18115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heWas</a:t>
            </a:r>
            <a:r>
              <a:rPr lang="en-US" dirty="0"/>
              <a:t> View Plot for  F203S</a:t>
            </a: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2ACEF918-DC1E-B61E-346C-EC0FEA12CAC5}"/>
              </a:ext>
            </a:extLst>
          </p:cNvPr>
          <p:cNvGrpSpPr/>
          <p:nvPr/>
        </p:nvGrpSpPr>
        <p:grpSpPr>
          <a:xfrm>
            <a:off x="226646" y="1598481"/>
            <a:ext cx="4456651" cy="4152023"/>
            <a:chOff x="226646" y="1598481"/>
            <a:chExt cx="4456651" cy="4152023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A9F17C67-F33C-F755-657F-5E5D8BA942DF}"/>
                </a:ext>
              </a:extLst>
            </p:cNvPr>
            <p:cNvGrpSpPr/>
            <p:nvPr/>
          </p:nvGrpSpPr>
          <p:grpSpPr>
            <a:xfrm>
              <a:off x="226646" y="1598481"/>
              <a:ext cx="4456651" cy="4152023"/>
              <a:chOff x="226646" y="1598481"/>
              <a:chExt cx="4456651" cy="4152023"/>
            </a:xfrm>
          </p:grpSpPr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523B57C1-2768-5C77-F1DB-C0EF680FC03B}"/>
                  </a:ext>
                </a:extLst>
              </p:cNvPr>
              <p:cNvGrpSpPr/>
              <p:nvPr/>
            </p:nvGrpSpPr>
            <p:grpSpPr>
              <a:xfrm>
                <a:off x="226646" y="1598481"/>
                <a:ext cx="4456651" cy="4152023"/>
                <a:chOff x="60971" y="1616225"/>
                <a:chExt cx="4456651" cy="4152023"/>
              </a:xfrm>
            </p:grpSpPr>
            <p:grpSp>
              <p:nvGrpSpPr>
                <p:cNvPr id="36" name="Group 35">
                  <a:extLst>
                    <a:ext uri="{FF2B5EF4-FFF2-40B4-BE49-F238E27FC236}">
                      <a16:creationId xmlns:a16="http://schemas.microsoft.com/office/drawing/2014/main" id="{EF5C16C7-CDFE-AB88-118E-160C266BE056}"/>
                    </a:ext>
                  </a:extLst>
                </p:cNvPr>
                <p:cNvGrpSpPr/>
                <p:nvPr/>
              </p:nvGrpSpPr>
              <p:grpSpPr>
                <a:xfrm>
                  <a:off x="60971" y="1629883"/>
                  <a:ext cx="4456651" cy="4138365"/>
                  <a:chOff x="60971" y="1629883"/>
                  <a:chExt cx="4456651" cy="4138365"/>
                </a:xfrm>
              </p:grpSpPr>
              <p:grpSp>
                <p:nvGrpSpPr>
                  <p:cNvPr id="17" name="Group 16">
                    <a:extLst>
                      <a:ext uri="{FF2B5EF4-FFF2-40B4-BE49-F238E27FC236}">
                        <a16:creationId xmlns:a16="http://schemas.microsoft.com/office/drawing/2014/main" id="{BA4008F2-3A11-F1D7-E984-5E483CDFAAE1}"/>
                      </a:ext>
                    </a:extLst>
                  </p:cNvPr>
                  <p:cNvGrpSpPr/>
                  <p:nvPr/>
                </p:nvGrpSpPr>
                <p:grpSpPr>
                  <a:xfrm>
                    <a:off x="60971" y="1647628"/>
                    <a:ext cx="4361710" cy="4120620"/>
                    <a:chOff x="252165" y="1677780"/>
                    <a:chExt cx="4361710" cy="4120620"/>
                  </a:xfrm>
                </p:grpSpPr>
                <p:pic>
                  <p:nvPicPr>
                    <p:cNvPr id="3" name="Picture 2" descr="A diagram of a graph&#10;&#10;Description automatically generated with medium confidence">
                      <a:extLst>
                        <a:ext uri="{FF2B5EF4-FFF2-40B4-BE49-F238E27FC236}">
                          <a16:creationId xmlns:a16="http://schemas.microsoft.com/office/drawing/2014/main" id="{C4A38664-B9CD-72DE-DA6D-36833830F25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52165" y="1677780"/>
                      <a:ext cx="4361710" cy="412062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</p:pic>
                <p:sp>
                  <p:nvSpPr>
                    <p:cNvPr id="12" name="Rectangle 11">
                      <a:extLst>
                        <a:ext uri="{FF2B5EF4-FFF2-40B4-BE49-F238E27FC236}">
                          <a16:creationId xmlns:a16="http://schemas.microsoft.com/office/drawing/2014/main" id="{D55CC92C-C4A8-8A27-4D17-C93EFE63096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89926" y="2089192"/>
                      <a:ext cx="1983716" cy="345776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" name="Rectangle 12">
                      <a:extLst>
                        <a:ext uri="{FF2B5EF4-FFF2-40B4-BE49-F238E27FC236}">
                          <a16:creationId xmlns:a16="http://schemas.microsoft.com/office/drawing/2014/main" id="{C53873C9-ACF0-1488-E1B9-CD7E55C7308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06866" y="1907523"/>
                      <a:ext cx="1362517" cy="13322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" name="Rectangle 13">
                      <a:extLst>
                        <a:ext uri="{FF2B5EF4-FFF2-40B4-BE49-F238E27FC236}">
                          <a16:creationId xmlns:a16="http://schemas.microsoft.com/office/drawing/2014/main" id="{9FE17C6E-5BAD-DF3C-0480-4B5E1C178C6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17785" y="1677780"/>
                      <a:ext cx="1682533" cy="147857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5" name="Rectangle 14">
                      <a:extLst>
                        <a:ext uri="{FF2B5EF4-FFF2-40B4-BE49-F238E27FC236}">
                          <a16:creationId xmlns:a16="http://schemas.microsoft.com/office/drawing/2014/main" id="{FF3039A3-EF75-B0A2-D437-70C51F461EA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24234" y="2230993"/>
                      <a:ext cx="205891" cy="11859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grpSp>
                <p:nvGrpSpPr>
                  <p:cNvPr id="18" name="Group 17">
                    <a:extLst>
                      <a:ext uri="{FF2B5EF4-FFF2-40B4-BE49-F238E27FC236}">
                        <a16:creationId xmlns:a16="http://schemas.microsoft.com/office/drawing/2014/main" id="{100D3EAA-4EE1-9813-B1F8-E4123207A78E}"/>
                      </a:ext>
                    </a:extLst>
                  </p:cNvPr>
                  <p:cNvGrpSpPr/>
                  <p:nvPr/>
                </p:nvGrpSpPr>
                <p:grpSpPr>
                  <a:xfrm>
                    <a:off x="618065" y="2165510"/>
                    <a:ext cx="1878853" cy="3284657"/>
                    <a:chOff x="359839" y="2181335"/>
                    <a:chExt cx="1878853" cy="3284657"/>
                  </a:xfrm>
                </p:grpSpPr>
                <p:sp>
                  <p:nvSpPr>
                    <p:cNvPr id="19" name="TextBox 18">
                      <a:extLst>
                        <a:ext uri="{FF2B5EF4-FFF2-40B4-BE49-F238E27FC236}">
                          <a16:creationId xmlns:a16="http://schemas.microsoft.com/office/drawing/2014/main" id="{28183196-6165-2EB6-A29E-DEF9D180FD7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2815" y="2181335"/>
                      <a:ext cx="176126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vular heart disease/ heart chamber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20" name="TextBox 19">
                      <a:extLst>
                        <a:ext uri="{FF2B5EF4-FFF2-40B4-BE49-F238E27FC236}">
                          <a16:creationId xmlns:a16="http://schemas.microsoft.com/office/drawing/2014/main" id="{842F332B-C927-AA71-D8BB-84D61DC5312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87132" y="2403631"/>
                      <a:ext cx="1526945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evated C-reactive protein (CRP)</a:t>
                      </a:r>
                    </a:p>
                  </p:txBody>
                </p:sp>
                <p:sp>
                  <p:nvSpPr>
                    <p:cNvPr id="21" name="TextBox 20">
                      <a:extLst>
                        <a:ext uri="{FF2B5EF4-FFF2-40B4-BE49-F238E27FC236}">
                          <a16:creationId xmlns:a16="http://schemas.microsoft.com/office/drawing/2014/main" id="{B92CC83B-C04C-6E18-5F7F-F12475FADF6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65208" y="2625927"/>
                      <a:ext cx="96284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dgkin's disease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22" name="TextBox 21">
                      <a:extLst>
                        <a:ext uri="{FF2B5EF4-FFF2-40B4-BE49-F238E27FC236}">
                          <a16:creationId xmlns:a16="http://schemas.microsoft.com/office/drawing/2014/main" id="{AD889756-B532-F528-A711-F7041FF0D1F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77473" y="2848224"/>
                      <a:ext cx="1350576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yneuropathy due to drug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23" name="TextBox 22">
                      <a:extLst>
                        <a:ext uri="{FF2B5EF4-FFF2-40B4-BE49-F238E27FC236}">
                          <a16:creationId xmlns:a16="http://schemas.microsoft.com/office/drawing/2014/main" id="{AFB24F71-22EE-50DA-9916-27DA338DE8E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61977" y="3070520"/>
                      <a:ext cx="765344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enomegaly</a:t>
                      </a:r>
                      <a:r>
                        <a:rPr lang="en-US" sz="7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4" name="TextBox 23">
                      <a:extLst>
                        <a:ext uri="{FF2B5EF4-FFF2-40B4-BE49-F238E27FC236}">
                          <a16:creationId xmlns:a16="http://schemas.microsoft.com/office/drawing/2014/main" id="{05C9C781-5559-B7B1-7384-27D1B82A83B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8861" y="3292817"/>
                      <a:ext cx="145983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rmatitis due to solar radiation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25" name="TextBox 24">
                      <a:extLst>
                        <a:ext uri="{FF2B5EF4-FFF2-40B4-BE49-F238E27FC236}">
                          <a16:creationId xmlns:a16="http://schemas.microsoft.com/office/drawing/2014/main" id="{FD397CE5-B9CD-4B13-2346-A5D7ED4466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0470" y="3515113"/>
                      <a:ext cx="1616960" cy="199780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stance addiction and disorder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26" name="TextBox 25">
                      <a:extLst>
                        <a:ext uri="{FF2B5EF4-FFF2-40B4-BE49-F238E27FC236}">
                          <a16:creationId xmlns:a16="http://schemas.microsoft.com/office/drawing/2014/main" id="{85D4592F-F7DD-E77A-7D3D-663D891FC7E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00739" y="3725022"/>
                      <a:ext cx="1031897" cy="2042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rt valve disorder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27" name="TextBox 26">
                      <a:extLst>
                        <a:ext uri="{FF2B5EF4-FFF2-40B4-BE49-F238E27FC236}">
                          <a16:creationId xmlns:a16="http://schemas.microsoft.com/office/drawing/2014/main" id="{F6F977B5-1876-005A-A44D-1718255E0A6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79944" y="3939426"/>
                      <a:ext cx="547377" cy="2034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graine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28" name="TextBox 27">
                      <a:extLst>
                        <a:ext uri="{FF2B5EF4-FFF2-40B4-BE49-F238E27FC236}">
                          <a16:creationId xmlns:a16="http://schemas.microsoft.com/office/drawing/2014/main" id="{1BA4754A-ECD9-B473-1F20-9204BC94CB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87132" y="4165068"/>
                      <a:ext cx="155156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/intrinsic cardiomyopathie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29" name="TextBox 28">
                      <a:extLst>
                        <a:ext uri="{FF2B5EF4-FFF2-40B4-BE49-F238E27FC236}">
                          <a16:creationId xmlns:a16="http://schemas.microsoft.com/office/drawing/2014/main" id="{2C5E286F-F359-463D-7A7E-ABD78A440E1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61977" y="4381308"/>
                      <a:ext cx="76758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ortic ectasia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30" name="TextBox 29">
                      <a:extLst>
                        <a:ext uri="{FF2B5EF4-FFF2-40B4-BE49-F238E27FC236}">
                          <a16:creationId xmlns:a16="http://schemas.microsoft.com/office/drawing/2014/main" id="{C6822678-7D4A-22FD-DA69-204122BD6A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9460" y="4603605"/>
                      <a:ext cx="1227861" cy="2078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eloproliferative disease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31" name="TextBox 30">
                      <a:extLst>
                        <a:ext uri="{FF2B5EF4-FFF2-40B4-BE49-F238E27FC236}">
                          <a16:creationId xmlns:a16="http://schemas.microsoft.com/office/drawing/2014/main" id="{67CC05C5-B2FE-A652-B33C-85181AE256C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9460" y="4821618"/>
                      <a:ext cx="1228978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Hodgkins lymphoma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32" name="TextBox 31">
                      <a:extLst>
                        <a:ext uri="{FF2B5EF4-FFF2-40B4-BE49-F238E27FC236}">
                          <a16:creationId xmlns:a16="http://schemas.microsoft.com/office/drawing/2014/main" id="{9F8BDF6D-829C-3794-EE5E-4347DC75AD0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7859" y="5056027"/>
                      <a:ext cx="1228979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eurisy; pleural effusion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33" name="TextBox 32">
                      <a:extLst>
                        <a:ext uri="{FF2B5EF4-FFF2-40B4-BE49-F238E27FC236}">
                          <a16:creationId xmlns:a16="http://schemas.microsoft.com/office/drawing/2014/main" id="{4C65C097-70AD-5E8E-1F22-02F44A6EE1E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9839" y="5266212"/>
                      <a:ext cx="1871556" cy="199780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of other lymphoid, histiocytic tissue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</p:grpSp>
              <p:grpSp>
                <p:nvGrpSpPr>
                  <p:cNvPr id="56" name="Group 55">
                    <a:extLst>
                      <a:ext uri="{FF2B5EF4-FFF2-40B4-BE49-F238E27FC236}">
                        <a16:creationId xmlns:a16="http://schemas.microsoft.com/office/drawing/2014/main" id="{F4576C2A-5A60-4D7D-F7F1-CEC35B6D7439}"/>
                      </a:ext>
                    </a:extLst>
                  </p:cNvPr>
                  <p:cNvGrpSpPr/>
                  <p:nvPr/>
                </p:nvGrpSpPr>
                <p:grpSpPr>
                  <a:xfrm>
                    <a:off x="2211858" y="1839109"/>
                    <a:ext cx="1741792" cy="230832"/>
                    <a:chOff x="1902074" y="1800576"/>
                    <a:chExt cx="1741792" cy="230832"/>
                  </a:xfrm>
                </p:grpSpPr>
                <p:sp>
                  <p:nvSpPr>
                    <p:cNvPr id="57" name="TextBox 56">
                      <a:extLst>
                        <a:ext uri="{FF2B5EF4-FFF2-40B4-BE49-F238E27FC236}">
                          <a16:creationId xmlns:a16="http://schemas.microsoft.com/office/drawing/2014/main" id="{290CA1EF-5812-E50C-47F3-129C0D9B5B4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62791" y="1800576"/>
                      <a:ext cx="481075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ta</a:t>
                      </a:r>
                    </a:p>
                  </p:txBody>
                </p:sp>
                <p:sp>
                  <p:nvSpPr>
                    <p:cNvPr id="58" name="TextBox 57">
                      <a:extLst>
                        <a:ext uri="{FF2B5EF4-FFF2-40B4-BE49-F238E27FC236}">
                          <a16:creationId xmlns:a16="http://schemas.microsoft.com/office/drawing/2014/main" id="{ABB1FA99-EDD0-6B3A-4BD9-EB333C3787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02074" y="1800576"/>
                      <a:ext cx="127059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log10(p value)</a:t>
                      </a:r>
                    </a:p>
                  </p:txBody>
                </p:sp>
              </p:grp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630B32F3-D07F-7F96-6673-91EE9BA11781}"/>
                      </a:ext>
                    </a:extLst>
                  </p:cNvPr>
                  <p:cNvSpPr txBox="1"/>
                  <p:nvPr/>
                </p:nvSpPr>
                <p:spPr>
                  <a:xfrm>
                    <a:off x="1297838" y="1629883"/>
                    <a:ext cx="229131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203S </a:t>
                    </a:r>
                    <a:r>
                      <a:rPr lang="en-US" sz="12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heWAS</a:t>
                    </a:r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View Plot</a:t>
                    </a:r>
                  </a:p>
                </p:txBody>
              </p:sp>
              <p:grpSp>
                <p:nvGrpSpPr>
                  <p:cNvPr id="35" name="Group 34">
                    <a:extLst>
                      <a:ext uri="{FF2B5EF4-FFF2-40B4-BE49-F238E27FC236}">
                        <a16:creationId xmlns:a16="http://schemas.microsoft.com/office/drawing/2014/main" id="{1195E7BB-E8B5-7348-451E-C110D7C7D065}"/>
                      </a:ext>
                    </a:extLst>
                  </p:cNvPr>
                  <p:cNvGrpSpPr/>
                  <p:nvPr/>
                </p:nvGrpSpPr>
                <p:grpSpPr>
                  <a:xfrm>
                    <a:off x="4064378" y="2130049"/>
                    <a:ext cx="453244" cy="200055"/>
                    <a:chOff x="4064378" y="2130049"/>
                    <a:chExt cx="453244" cy="200055"/>
                  </a:xfrm>
                </p:grpSpPr>
                <p:sp>
                  <p:nvSpPr>
                    <p:cNvPr id="55" name="TextBox 54">
                      <a:extLst>
                        <a:ext uri="{FF2B5EF4-FFF2-40B4-BE49-F238E27FC236}">
                          <a16:creationId xmlns:a16="http://schemas.microsoft.com/office/drawing/2014/main" id="{A66D11CE-788F-E2CE-5AB7-2C65E1C118A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76373" y="2130049"/>
                      <a:ext cx="441249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R</a:t>
                      </a:r>
                    </a:p>
                  </p:txBody>
                </p:sp>
                <p:sp>
                  <p:nvSpPr>
                    <p:cNvPr id="11" name="Oval 10">
                      <a:extLst>
                        <a:ext uri="{FF2B5EF4-FFF2-40B4-BE49-F238E27FC236}">
                          <a16:creationId xmlns:a16="http://schemas.microsoft.com/office/drawing/2014/main" id="{7F4D8BC0-5D7A-DF27-5C51-1C3D51FA8E5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64378" y="2200841"/>
                      <a:ext cx="68662" cy="67252"/>
                    </a:xfrm>
                    <a:prstGeom prst="ellipse">
                      <a:avLst/>
                    </a:prstGeom>
                    <a:solidFill>
                      <a:srgbClr val="3333FF"/>
                    </a:solidFill>
                    <a:ln>
                      <a:solidFill>
                        <a:srgbClr val="3333FF"/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</p:grpSp>
            <p:sp>
              <p:nvSpPr>
                <p:cNvPr id="4" name="Rectangle 3">
                  <a:extLst>
                    <a:ext uri="{FF2B5EF4-FFF2-40B4-BE49-F238E27FC236}">
                      <a16:creationId xmlns:a16="http://schemas.microsoft.com/office/drawing/2014/main" id="{03622B2C-513C-5081-133E-2C87CDA431F6}"/>
                    </a:ext>
                  </a:extLst>
                </p:cNvPr>
                <p:cNvSpPr/>
                <p:nvPr/>
              </p:nvSpPr>
              <p:spPr>
                <a:xfrm>
                  <a:off x="618065" y="1616225"/>
                  <a:ext cx="3804616" cy="4152023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608C4530-3450-5F73-28A5-E5B3BC03C2C1}"/>
                  </a:ext>
                </a:extLst>
              </p:cNvPr>
              <p:cNvSpPr/>
              <p:nvPr/>
            </p:nvSpPr>
            <p:spPr>
              <a:xfrm>
                <a:off x="2594551" y="1852480"/>
                <a:ext cx="789519" cy="14689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D4C286E-B7CA-239A-A6EA-2867E49D83B0}"/>
                </a:ext>
              </a:extLst>
            </p:cNvPr>
            <p:cNvSpPr txBox="1"/>
            <p:nvPr/>
          </p:nvSpPr>
          <p:spPr>
            <a:xfrm>
              <a:off x="2406856" y="1795124"/>
              <a:ext cx="1178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‒log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p value)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9F4D0BD3-CC8F-FDE3-5063-EA27933354A7}"/>
              </a:ext>
            </a:extLst>
          </p:cNvPr>
          <p:cNvGrpSpPr/>
          <p:nvPr/>
        </p:nvGrpSpPr>
        <p:grpSpPr>
          <a:xfrm>
            <a:off x="5030852" y="1598481"/>
            <a:ext cx="4113148" cy="4129461"/>
            <a:chOff x="5036567" y="1516703"/>
            <a:chExt cx="4113148" cy="4129461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9EBDB10A-BBB1-4E5C-3E44-FA6D9F4046CA}"/>
                </a:ext>
              </a:extLst>
            </p:cNvPr>
            <p:cNvGrpSpPr/>
            <p:nvPr/>
          </p:nvGrpSpPr>
          <p:grpSpPr>
            <a:xfrm>
              <a:off x="5036567" y="1516703"/>
              <a:ext cx="4113148" cy="4129461"/>
              <a:chOff x="5036567" y="1516703"/>
              <a:chExt cx="4113148" cy="4129461"/>
            </a:xfrm>
          </p:grpSpPr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A2673499-C8B0-2C47-41E6-F1908E96D9B1}"/>
                  </a:ext>
                </a:extLst>
              </p:cNvPr>
              <p:cNvGrpSpPr/>
              <p:nvPr/>
            </p:nvGrpSpPr>
            <p:grpSpPr>
              <a:xfrm>
                <a:off x="5036567" y="1516703"/>
                <a:ext cx="4113148" cy="4129461"/>
                <a:chOff x="4908230" y="1621043"/>
                <a:chExt cx="4113148" cy="4129461"/>
              </a:xfrm>
            </p:grpSpPr>
            <p:sp>
              <p:nvSpPr>
                <p:cNvPr id="5" name="Rectangle 4">
                  <a:extLst>
                    <a:ext uri="{FF2B5EF4-FFF2-40B4-BE49-F238E27FC236}">
                      <a16:creationId xmlns:a16="http://schemas.microsoft.com/office/drawing/2014/main" id="{A9D528F4-F9D7-C522-5670-7B47A634EFBA}"/>
                    </a:ext>
                  </a:extLst>
                </p:cNvPr>
                <p:cNvSpPr/>
                <p:nvPr/>
              </p:nvSpPr>
              <p:spPr>
                <a:xfrm>
                  <a:off x="4908230" y="1629883"/>
                  <a:ext cx="3987489" cy="4120621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EB30242A-17E3-192C-4CB9-C8D6E8C42540}"/>
                    </a:ext>
                  </a:extLst>
                </p:cNvPr>
                <p:cNvGrpSpPr/>
                <p:nvPr/>
              </p:nvGrpSpPr>
              <p:grpSpPr>
                <a:xfrm>
                  <a:off x="4928640" y="1621043"/>
                  <a:ext cx="4092738" cy="3895762"/>
                  <a:chOff x="4928640" y="1621043"/>
                  <a:chExt cx="4092738" cy="3895762"/>
                </a:xfrm>
              </p:grpSpPr>
              <p:grpSp>
                <p:nvGrpSpPr>
                  <p:cNvPr id="68" name="Group 67">
                    <a:extLst>
                      <a:ext uri="{FF2B5EF4-FFF2-40B4-BE49-F238E27FC236}">
                        <a16:creationId xmlns:a16="http://schemas.microsoft.com/office/drawing/2014/main" id="{62B03265-4C53-C923-93BD-1EC3AE8EB90A}"/>
                      </a:ext>
                    </a:extLst>
                  </p:cNvPr>
                  <p:cNvGrpSpPr/>
                  <p:nvPr/>
                </p:nvGrpSpPr>
                <p:grpSpPr>
                  <a:xfrm>
                    <a:off x="4928640" y="1664810"/>
                    <a:ext cx="3918765" cy="3851995"/>
                    <a:chOff x="4928640" y="1664810"/>
                    <a:chExt cx="3918765" cy="3851995"/>
                  </a:xfrm>
                </p:grpSpPr>
                <p:pic>
                  <p:nvPicPr>
                    <p:cNvPr id="63" name="Picture 62" descr="A diagram of a diagram&#10;&#10;Description automatically generated with medium confidence">
                      <a:extLst>
                        <a:ext uri="{FF2B5EF4-FFF2-40B4-BE49-F238E27FC236}">
                          <a16:creationId xmlns:a16="http://schemas.microsoft.com/office/drawing/2014/main" id="{F093A207-CD9D-925E-8BE8-894C85C7D07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405" r="1872"/>
                    <a:stretch/>
                  </p:blipFill>
                  <p:spPr>
                    <a:xfrm>
                      <a:off x="4976954" y="1670711"/>
                      <a:ext cx="3870451" cy="384609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64" name="Rectangle 63">
                      <a:extLst>
                        <a:ext uri="{FF2B5EF4-FFF2-40B4-BE49-F238E27FC236}">
                          <a16:creationId xmlns:a16="http://schemas.microsoft.com/office/drawing/2014/main" id="{D0C24224-0103-60DA-CF13-AA038D6C7CD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019295" y="1664810"/>
                      <a:ext cx="1616853" cy="209226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5" name="Rectangle 64">
                      <a:extLst>
                        <a:ext uri="{FF2B5EF4-FFF2-40B4-BE49-F238E27FC236}">
                          <a16:creationId xmlns:a16="http://schemas.microsoft.com/office/drawing/2014/main" id="{5B097337-A398-88ED-29EB-07B4630F3CE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928640" y="2165509"/>
                      <a:ext cx="2095890" cy="3062607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6" name="Rectangle 65">
                      <a:extLst>
                        <a:ext uri="{FF2B5EF4-FFF2-40B4-BE49-F238E27FC236}">
                          <a16:creationId xmlns:a16="http://schemas.microsoft.com/office/drawing/2014/main" id="{501AE2E3-BC5E-12B8-C49F-A0C62029166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128711" y="1877371"/>
                      <a:ext cx="1281363" cy="13322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7" name="Rectangle 66">
                      <a:extLst>
                        <a:ext uri="{FF2B5EF4-FFF2-40B4-BE49-F238E27FC236}">
                          <a16:creationId xmlns:a16="http://schemas.microsoft.com/office/drawing/2014/main" id="{55931120-04C1-B38A-C9D1-77A0C7045FD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59550" y="2142078"/>
                      <a:ext cx="187855" cy="13483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grpSp>
                <p:nvGrpSpPr>
                  <p:cNvPr id="69" name="Group 68">
                    <a:extLst>
                      <a:ext uri="{FF2B5EF4-FFF2-40B4-BE49-F238E27FC236}">
                        <a16:creationId xmlns:a16="http://schemas.microsoft.com/office/drawing/2014/main" id="{F4C81C5E-40C0-BB51-4754-C0FA055E66B9}"/>
                      </a:ext>
                    </a:extLst>
                  </p:cNvPr>
                  <p:cNvGrpSpPr/>
                  <p:nvPr/>
                </p:nvGrpSpPr>
                <p:grpSpPr>
                  <a:xfrm>
                    <a:off x="5054199" y="2148063"/>
                    <a:ext cx="2077956" cy="3078024"/>
                    <a:chOff x="4780287" y="2148471"/>
                    <a:chExt cx="2077956" cy="3078024"/>
                  </a:xfrm>
                </p:grpSpPr>
                <p:sp>
                  <p:nvSpPr>
                    <p:cNvPr id="70" name="TextBox 69">
                      <a:extLst>
                        <a:ext uri="{FF2B5EF4-FFF2-40B4-BE49-F238E27FC236}">
                          <a16:creationId xmlns:a16="http://schemas.microsoft.com/office/drawing/2014/main" id="{14F4EEB7-0594-327E-3178-96E2899387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90238" y="2148471"/>
                      <a:ext cx="135834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ndylolisthesis, congenital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DB2601CA-9DCB-94E2-B7B2-54AF41874D4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828861" y="2360934"/>
                      <a:ext cx="1015547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tral origin vertigo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72" name="TextBox 71">
                      <a:extLst>
                        <a:ext uri="{FF2B5EF4-FFF2-40B4-BE49-F238E27FC236}">
                          <a16:creationId xmlns:a16="http://schemas.microsoft.com/office/drawing/2014/main" id="{CB3D364F-B316-F678-CB2D-0376696CF6A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79357" y="2561285"/>
                      <a:ext cx="76559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tic atrophy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73" name="TextBox 72">
                      <a:extLst>
                        <a:ext uri="{FF2B5EF4-FFF2-40B4-BE49-F238E27FC236}">
                          <a16:creationId xmlns:a16="http://schemas.microsoft.com/office/drawing/2014/main" id="{5AACE29B-D1D0-7F1E-0AD3-D384F63BC35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52837" y="2761636"/>
                      <a:ext cx="1289784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allopathic lesions NEC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74" name="TextBox 73">
                      <a:extLst>
                        <a:ext uri="{FF2B5EF4-FFF2-40B4-BE49-F238E27FC236}">
                          <a16:creationId xmlns:a16="http://schemas.microsoft.com/office/drawing/2014/main" id="{EAEFD988-BB40-E4E8-B3F9-18C8C353B6D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80287" y="2968043"/>
                      <a:ext cx="2065844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genital musculoskeletal deformities of spine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75" name="TextBox 74">
                      <a:extLst>
                        <a:ext uri="{FF2B5EF4-FFF2-40B4-BE49-F238E27FC236}">
                          <a16:creationId xmlns:a16="http://schemas.microsoft.com/office/drawing/2014/main" id="{87457B8D-515A-962E-6795-2923631FC89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01572" y="3174450"/>
                      <a:ext cx="164889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teoarthrosis, localized, secondary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76" name="TextBox 75">
                      <a:extLst>
                        <a:ext uri="{FF2B5EF4-FFF2-40B4-BE49-F238E27FC236}">
                          <a16:creationId xmlns:a16="http://schemas.microsoft.com/office/drawing/2014/main" id="{59210D01-65AC-DE7B-4BDA-D6A76F55B0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91469" y="3386917"/>
                      <a:ext cx="758995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ortic ectasia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77" name="TextBox 76">
                      <a:extLst>
                        <a:ext uri="{FF2B5EF4-FFF2-40B4-BE49-F238E27FC236}">
                          <a16:creationId xmlns:a16="http://schemas.microsoft.com/office/drawing/2014/main" id="{24E4098C-0A07-95A1-EB15-5C9C9143DC1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11903" y="3587271"/>
                      <a:ext cx="113910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nic pain syndrome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78" name="TextBox 77">
                      <a:extLst>
                        <a:ext uri="{FF2B5EF4-FFF2-40B4-BE49-F238E27FC236}">
                          <a16:creationId xmlns:a16="http://schemas.microsoft.com/office/drawing/2014/main" id="{2228F494-2DB2-CE84-CA8C-CECA4E8977D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59309" y="3799733"/>
                      <a:ext cx="178564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vular heart disease/ heart chamber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79" name="TextBox 78">
                      <a:extLst>
                        <a:ext uri="{FF2B5EF4-FFF2-40B4-BE49-F238E27FC236}">
                          <a16:creationId xmlns:a16="http://schemas.microsoft.com/office/drawing/2014/main" id="{33ED5E70-40F7-6FDB-35BC-158DACBFC40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894927" y="4012194"/>
                      <a:ext cx="94948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rsion dystonia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80" name="TextBox 79">
                      <a:extLst>
                        <a:ext uri="{FF2B5EF4-FFF2-40B4-BE49-F238E27FC236}">
                          <a16:creationId xmlns:a16="http://schemas.microsoft.com/office/drawing/2014/main" id="{3F6C7BA1-E7DD-DCC5-3531-9A2DE1C9415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73301" y="4206494"/>
                      <a:ext cx="775376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e disease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81" name="TextBox 80">
                      <a:extLst>
                        <a:ext uri="{FF2B5EF4-FFF2-40B4-BE49-F238E27FC236}">
                          <a16:creationId xmlns:a16="http://schemas.microsoft.com/office/drawing/2014/main" id="{FFDAEDD6-920A-5F9A-1479-47124548E65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72602" y="4412901"/>
                      <a:ext cx="178564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x regional/central pain syndrome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82" name="TextBox 81">
                      <a:extLst>
                        <a:ext uri="{FF2B5EF4-FFF2-40B4-BE49-F238E27FC236}">
                          <a16:creationId xmlns:a16="http://schemas.microsoft.com/office/drawing/2014/main" id="{A2CF4DBF-F58D-2F6F-DA7B-BBC063AE61C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85252" y="4625364"/>
                      <a:ext cx="870147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rmatochalasi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83" name="TextBox 82">
                      <a:extLst>
                        <a:ext uri="{FF2B5EF4-FFF2-40B4-BE49-F238E27FC236}">
                          <a16:creationId xmlns:a16="http://schemas.microsoft.com/office/drawing/2014/main" id="{748A7614-52EA-4984-4160-898A885D4C1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54932" y="5026440"/>
                      <a:ext cx="1993745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orders of optic nerve and visual pathway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  <p:sp>
                  <p:nvSpPr>
                    <p:cNvPr id="84" name="TextBox 83">
                      <a:extLst>
                        <a:ext uri="{FF2B5EF4-FFF2-40B4-BE49-F238E27FC236}">
                          <a16:creationId xmlns:a16="http://schemas.microsoft.com/office/drawing/2014/main" id="{E15ECF98-7735-79A5-C12A-0C0574EA913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97260" y="4825715"/>
                      <a:ext cx="105132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irochetal infection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p:txBody>
                </p:sp>
              </p:grpSp>
              <p:grpSp>
                <p:nvGrpSpPr>
                  <p:cNvPr id="86" name="Group 85">
                    <a:extLst>
                      <a:ext uri="{FF2B5EF4-FFF2-40B4-BE49-F238E27FC236}">
                        <a16:creationId xmlns:a16="http://schemas.microsoft.com/office/drawing/2014/main" id="{E50EEBA9-2EB1-02C0-EF6B-1DE010FF3E9B}"/>
                      </a:ext>
                    </a:extLst>
                  </p:cNvPr>
                  <p:cNvGrpSpPr/>
                  <p:nvPr/>
                </p:nvGrpSpPr>
                <p:grpSpPr>
                  <a:xfrm>
                    <a:off x="6841223" y="1813826"/>
                    <a:ext cx="1616853" cy="256115"/>
                    <a:chOff x="6509097" y="1752417"/>
                    <a:chExt cx="1616853" cy="256115"/>
                  </a:xfrm>
                </p:grpSpPr>
                <p:sp>
                  <p:nvSpPr>
                    <p:cNvPr id="87" name="TextBox 86">
                      <a:extLst>
                        <a:ext uri="{FF2B5EF4-FFF2-40B4-BE49-F238E27FC236}">
                          <a16:creationId xmlns:a16="http://schemas.microsoft.com/office/drawing/2014/main" id="{D592EAB8-D70E-5CAA-BA00-41687D3E60F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09097" y="1752417"/>
                      <a:ext cx="127059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log10(p value)</a:t>
                      </a:r>
                    </a:p>
                  </p:txBody>
                </p:sp>
                <p:sp>
                  <p:nvSpPr>
                    <p:cNvPr id="88" name="TextBox 87">
                      <a:extLst>
                        <a:ext uri="{FF2B5EF4-FFF2-40B4-BE49-F238E27FC236}">
                          <a16:creationId xmlns:a16="http://schemas.microsoft.com/office/drawing/2014/main" id="{D8448ED1-49E6-E503-B4DB-F8DB6AEC305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644875" y="1777700"/>
                      <a:ext cx="481075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ta</a:t>
                      </a:r>
                    </a:p>
                  </p:txBody>
                </p:sp>
              </p:grpSp>
              <p:sp>
                <p:nvSpPr>
                  <p:cNvPr id="89" name="TextBox 88">
                    <a:extLst>
                      <a:ext uri="{FF2B5EF4-FFF2-40B4-BE49-F238E27FC236}">
                        <a16:creationId xmlns:a16="http://schemas.microsoft.com/office/drawing/2014/main" id="{A1D47286-8BCD-DC1A-11A7-F172E61EA239}"/>
                      </a:ext>
                    </a:extLst>
                  </p:cNvPr>
                  <p:cNvSpPr txBox="1"/>
                  <p:nvPr/>
                </p:nvSpPr>
                <p:spPr>
                  <a:xfrm>
                    <a:off x="5914243" y="1621043"/>
                    <a:ext cx="229131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182K </a:t>
                    </a:r>
                    <a:r>
                      <a:rPr lang="en-US" sz="12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heWAS</a:t>
                    </a:r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View Plot</a:t>
                    </a:r>
                  </a:p>
                </p:txBody>
              </p:sp>
              <p:grpSp>
                <p:nvGrpSpPr>
                  <p:cNvPr id="38" name="Group 37">
                    <a:extLst>
                      <a:ext uri="{FF2B5EF4-FFF2-40B4-BE49-F238E27FC236}">
                        <a16:creationId xmlns:a16="http://schemas.microsoft.com/office/drawing/2014/main" id="{2B022B4F-96F7-86EF-301A-E7B92CBC3108}"/>
                      </a:ext>
                    </a:extLst>
                  </p:cNvPr>
                  <p:cNvGrpSpPr/>
                  <p:nvPr/>
                </p:nvGrpSpPr>
                <p:grpSpPr>
                  <a:xfrm>
                    <a:off x="8580129" y="2130049"/>
                    <a:ext cx="441249" cy="200055"/>
                    <a:chOff x="8580129" y="2130049"/>
                    <a:chExt cx="441249" cy="200055"/>
                  </a:xfrm>
                </p:grpSpPr>
                <p:sp>
                  <p:nvSpPr>
                    <p:cNvPr id="85" name="TextBox 84">
                      <a:extLst>
                        <a:ext uri="{FF2B5EF4-FFF2-40B4-BE49-F238E27FC236}">
                          <a16:creationId xmlns:a16="http://schemas.microsoft.com/office/drawing/2014/main" id="{4855514A-403D-91A7-4D11-7AB381EFC3D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580129" y="2130049"/>
                      <a:ext cx="441249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R</a:t>
                      </a:r>
                    </a:p>
                  </p:txBody>
                </p:sp>
                <p:sp>
                  <p:nvSpPr>
                    <p:cNvPr id="16" name="Oval 15">
                      <a:extLst>
                        <a:ext uri="{FF2B5EF4-FFF2-40B4-BE49-F238E27FC236}">
                          <a16:creationId xmlns:a16="http://schemas.microsoft.com/office/drawing/2014/main" id="{C216C79D-A3FA-0D24-0426-D3AA1CDB85B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580129" y="2196450"/>
                      <a:ext cx="68662" cy="67252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E53232"/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</p:grpSp>
          </p:grpSp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C4705E7F-6BB7-D037-ABE6-B0E9C0787E85}"/>
                  </a:ext>
                </a:extLst>
              </p:cNvPr>
              <p:cNvSpPr/>
              <p:nvPr/>
            </p:nvSpPr>
            <p:spPr>
              <a:xfrm>
                <a:off x="7188237" y="1769696"/>
                <a:ext cx="823356" cy="12741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BA9B3CA-3482-6A07-0E28-245EEF8E1675}"/>
                </a:ext>
              </a:extLst>
            </p:cNvPr>
            <p:cNvSpPr txBox="1"/>
            <p:nvPr/>
          </p:nvSpPr>
          <p:spPr>
            <a:xfrm>
              <a:off x="7022368" y="1703429"/>
              <a:ext cx="1178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‒log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p value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25215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68EB4DC-078A-8329-B3F4-BC428C0C418C}"/>
              </a:ext>
            </a:extLst>
          </p:cNvPr>
          <p:cNvSpPr txBox="1"/>
          <p:nvPr/>
        </p:nvSpPr>
        <p:spPr>
          <a:xfrm>
            <a:off x="296470" y="282587"/>
            <a:ext cx="2895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59C3AED-0082-F67F-E2DE-0F40DE1F9D0C}"/>
              </a:ext>
            </a:extLst>
          </p:cNvPr>
          <p:cNvSpPr txBox="1"/>
          <p:nvPr/>
        </p:nvSpPr>
        <p:spPr>
          <a:xfrm>
            <a:off x="1266828" y="1613169"/>
            <a:ext cx="2895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214C 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63D88EF2-B728-4B2D-881A-7C37D776AF65}"/>
              </a:ext>
            </a:extLst>
          </p:cNvPr>
          <p:cNvGrpSpPr/>
          <p:nvPr/>
        </p:nvGrpSpPr>
        <p:grpSpPr>
          <a:xfrm>
            <a:off x="667109" y="1280490"/>
            <a:ext cx="7046674" cy="5294923"/>
            <a:chOff x="667109" y="1280490"/>
            <a:chExt cx="7046674" cy="5294923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DFB63606-671C-E479-B6BC-37DB6875F8B7}"/>
                </a:ext>
              </a:extLst>
            </p:cNvPr>
            <p:cNvGrpSpPr/>
            <p:nvPr/>
          </p:nvGrpSpPr>
          <p:grpSpPr>
            <a:xfrm>
              <a:off x="726829" y="1280490"/>
              <a:ext cx="6986954" cy="5294923"/>
              <a:chOff x="726829" y="1280490"/>
              <a:chExt cx="6986954" cy="5294923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307AC544-FE51-79C1-0BD2-E6340EC34AA8}"/>
                  </a:ext>
                </a:extLst>
              </p:cNvPr>
              <p:cNvGrpSpPr/>
              <p:nvPr/>
            </p:nvGrpSpPr>
            <p:grpSpPr>
              <a:xfrm>
                <a:off x="726829" y="1280490"/>
                <a:ext cx="6986954" cy="5294923"/>
                <a:chOff x="828429" y="922215"/>
                <a:chExt cx="6986954" cy="5294923"/>
              </a:xfrm>
            </p:grpSpPr>
            <p:grpSp>
              <p:nvGrpSpPr>
                <p:cNvPr id="6" name="Group 5">
                  <a:extLst>
                    <a:ext uri="{FF2B5EF4-FFF2-40B4-BE49-F238E27FC236}">
                      <a16:creationId xmlns:a16="http://schemas.microsoft.com/office/drawing/2014/main" id="{4727CFC8-228F-1D90-3295-CEDCBA7BB614}"/>
                    </a:ext>
                  </a:extLst>
                </p:cNvPr>
                <p:cNvGrpSpPr/>
                <p:nvPr/>
              </p:nvGrpSpPr>
              <p:grpSpPr>
                <a:xfrm>
                  <a:off x="828429" y="922215"/>
                  <a:ext cx="6986954" cy="5294923"/>
                  <a:chOff x="820614" y="1367692"/>
                  <a:chExt cx="6986954" cy="5294923"/>
                </a:xfrm>
              </p:grpSpPr>
              <p:pic>
                <p:nvPicPr>
                  <p:cNvPr id="4" name="Picture 3" descr="A screen shot of a screen&#10;&#10;Description automatically generated">
                    <a:extLst>
                      <a:ext uri="{FF2B5EF4-FFF2-40B4-BE49-F238E27FC236}">
                        <a16:creationId xmlns:a16="http://schemas.microsoft.com/office/drawing/2014/main" id="{256265E9-A4EA-5C43-A027-BD325DD505D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2803" r="23589"/>
                  <a:stretch/>
                </p:blipFill>
                <p:spPr>
                  <a:xfrm>
                    <a:off x="820614" y="2008354"/>
                    <a:ext cx="6986954" cy="4654261"/>
                  </a:xfrm>
                  <a:prstGeom prst="rect">
                    <a:avLst/>
                  </a:prstGeom>
                </p:spPr>
              </p:pic>
              <p:sp>
                <p:nvSpPr>
                  <p:cNvPr id="5" name="Rectangle 4">
                    <a:extLst>
                      <a:ext uri="{FF2B5EF4-FFF2-40B4-BE49-F238E27FC236}">
                        <a16:creationId xmlns:a16="http://schemas.microsoft.com/office/drawing/2014/main" id="{6F6AC856-7A12-EA8F-8E75-79EA0A0BFDCA}"/>
                      </a:ext>
                    </a:extLst>
                  </p:cNvPr>
                  <p:cNvSpPr/>
                  <p:nvPr/>
                </p:nvSpPr>
                <p:spPr>
                  <a:xfrm>
                    <a:off x="2586892" y="1367692"/>
                    <a:ext cx="3563816" cy="4571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id="{F5E59773-5037-30EC-401C-9676AFD062C0}"/>
                    </a:ext>
                  </a:extLst>
                </p:cNvPr>
                <p:cNvSpPr/>
                <p:nvPr/>
              </p:nvSpPr>
              <p:spPr>
                <a:xfrm>
                  <a:off x="2657230" y="1562877"/>
                  <a:ext cx="3704493" cy="6134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891BC380-F60E-2EC9-3AA4-ADC64A19D91F}"/>
                  </a:ext>
                </a:extLst>
              </p:cNvPr>
              <p:cNvSpPr/>
              <p:nvPr/>
            </p:nvSpPr>
            <p:spPr>
              <a:xfrm>
                <a:off x="726829" y="3191317"/>
                <a:ext cx="205738" cy="82962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D261CCE-B713-0A06-D7C1-C2317830887F}"/>
                </a:ext>
              </a:extLst>
            </p:cNvPr>
            <p:cNvSpPr txBox="1"/>
            <p:nvPr/>
          </p:nvSpPr>
          <p:spPr>
            <a:xfrm rot="16200000">
              <a:off x="170314" y="3467628"/>
              <a:ext cx="127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log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p value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170534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68EB4DC-078A-8329-B3F4-BC428C0C418C}"/>
              </a:ext>
            </a:extLst>
          </p:cNvPr>
          <p:cNvSpPr txBox="1"/>
          <p:nvPr/>
        </p:nvSpPr>
        <p:spPr>
          <a:xfrm>
            <a:off x="296470" y="282587"/>
            <a:ext cx="2895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59C3AED-0082-F67F-E2DE-0F40DE1F9D0C}"/>
              </a:ext>
            </a:extLst>
          </p:cNvPr>
          <p:cNvSpPr txBox="1"/>
          <p:nvPr/>
        </p:nvSpPr>
        <p:spPr>
          <a:xfrm>
            <a:off x="649154" y="1140705"/>
            <a:ext cx="2895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03S 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59954D1B-AAB6-CABF-7D9C-2B75C271606C}"/>
              </a:ext>
            </a:extLst>
          </p:cNvPr>
          <p:cNvGrpSpPr/>
          <p:nvPr/>
        </p:nvGrpSpPr>
        <p:grpSpPr>
          <a:xfrm>
            <a:off x="1102124" y="1722691"/>
            <a:ext cx="8041875" cy="3954586"/>
            <a:chOff x="1102124" y="1722691"/>
            <a:chExt cx="8041875" cy="395458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7F266E3C-8AA4-A0BE-F518-6BD13E446B5A}"/>
                </a:ext>
              </a:extLst>
            </p:cNvPr>
            <p:cNvGrpSpPr/>
            <p:nvPr/>
          </p:nvGrpSpPr>
          <p:grpSpPr>
            <a:xfrm>
              <a:off x="1102124" y="1722691"/>
              <a:ext cx="8041875" cy="3954586"/>
              <a:chOff x="1102124" y="1722691"/>
              <a:chExt cx="8041875" cy="3954586"/>
            </a:xfrm>
          </p:grpSpPr>
          <p:pic>
            <p:nvPicPr>
              <p:cNvPr id="5" name="Picture 4" descr="A rainbow colored text on a white background&#10;&#10;Description automatically generated">
                <a:extLst>
                  <a:ext uri="{FF2B5EF4-FFF2-40B4-BE49-F238E27FC236}">
                    <a16:creationId xmlns:a16="http://schemas.microsoft.com/office/drawing/2014/main" id="{4BE014FA-8251-FAAF-8709-D999C59E68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02124" y="1722691"/>
                <a:ext cx="8041875" cy="3954586"/>
              </a:xfrm>
              <a:prstGeom prst="rect">
                <a:avLst/>
              </a:prstGeom>
            </p:spPr>
          </p:pic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id="{CEACE22B-B3C0-D821-A533-2B588936801E}"/>
                  </a:ext>
                </a:extLst>
              </p:cNvPr>
              <p:cNvSpPr/>
              <p:nvPr/>
            </p:nvSpPr>
            <p:spPr>
              <a:xfrm>
                <a:off x="1641075" y="2852201"/>
                <a:ext cx="163502" cy="72062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678051C-457B-C711-E3C1-593CC7EE7F6D}"/>
                </a:ext>
              </a:extLst>
            </p:cNvPr>
            <p:cNvSpPr txBox="1"/>
            <p:nvPr/>
          </p:nvSpPr>
          <p:spPr>
            <a:xfrm rot="16200000">
              <a:off x="1087531" y="3183015"/>
              <a:ext cx="127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log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p value)</a:t>
              </a:r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D1648A7A-750A-C9D5-8BD5-37AA023BD412}"/>
              </a:ext>
            </a:extLst>
          </p:cNvPr>
          <p:cNvSpPr/>
          <p:nvPr/>
        </p:nvSpPr>
        <p:spPr>
          <a:xfrm>
            <a:off x="7469372" y="1770321"/>
            <a:ext cx="1674628" cy="28548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697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68EB4DC-078A-8329-B3F4-BC428C0C418C}"/>
              </a:ext>
            </a:extLst>
          </p:cNvPr>
          <p:cNvSpPr txBox="1"/>
          <p:nvPr/>
        </p:nvSpPr>
        <p:spPr>
          <a:xfrm>
            <a:off x="296470" y="282587"/>
            <a:ext cx="2895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59C3AED-0082-F67F-E2DE-0F40DE1F9D0C}"/>
              </a:ext>
            </a:extLst>
          </p:cNvPr>
          <p:cNvSpPr txBox="1"/>
          <p:nvPr/>
        </p:nvSpPr>
        <p:spPr>
          <a:xfrm>
            <a:off x="1422104" y="1051395"/>
            <a:ext cx="2895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182K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1ED15FFB-98B5-310F-3C97-6DF92E933C7D}"/>
              </a:ext>
            </a:extLst>
          </p:cNvPr>
          <p:cNvGrpSpPr/>
          <p:nvPr/>
        </p:nvGrpSpPr>
        <p:grpSpPr>
          <a:xfrm>
            <a:off x="845276" y="1492369"/>
            <a:ext cx="6927124" cy="4521269"/>
            <a:chOff x="845276" y="1492369"/>
            <a:chExt cx="6927124" cy="4521269"/>
          </a:xfrm>
        </p:grpSpPr>
        <p:pic>
          <p:nvPicPr>
            <p:cNvPr id="10" name="Picture 9" descr="A screen shot of a screen&#10;&#10;Description automatically generated">
              <a:extLst>
                <a:ext uri="{FF2B5EF4-FFF2-40B4-BE49-F238E27FC236}">
                  <a16:creationId xmlns:a16="http://schemas.microsoft.com/office/drawing/2014/main" id="{EF1DFC03-33D7-E4AA-192A-346828FA45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780" r="24245"/>
            <a:stretch/>
          </p:blipFill>
          <p:spPr>
            <a:xfrm>
              <a:off x="845276" y="1492369"/>
              <a:ext cx="6927124" cy="4521269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2CB794B-BA8A-3907-D698-B9F7EF0D39F2}"/>
                </a:ext>
              </a:extLst>
            </p:cNvPr>
            <p:cNvSpPr/>
            <p:nvPr/>
          </p:nvSpPr>
          <p:spPr>
            <a:xfrm>
              <a:off x="845276" y="2646310"/>
              <a:ext cx="208403" cy="7826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3E91DCE-8954-F349-812A-5894A46819AA}"/>
              </a:ext>
            </a:extLst>
          </p:cNvPr>
          <p:cNvSpPr txBox="1"/>
          <p:nvPr/>
        </p:nvSpPr>
        <p:spPr>
          <a:xfrm rot="16200000">
            <a:off x="209980" y="2899156"/>
            <a:ext cx="1270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p value)</a:t>
            </a:r>
          </a:p>
        </p:txBody>
      </p:sp>
    </p:spTree>
    <p:extLst>
      <p:ext uri="{BB962C8B-B14F-4D97-AF65-F5344CB8AC3E}">
        <p14:creationId xmlns:p14="http://schemas.microsoft.com/office/powerpoint/2010/main" val="1530862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8B9A436-7B41-A5C7-2D0B-34944182FD7A}"/>
              </a:ext>
            </a:extLst>
          </p:cNvPr>
          <p:cNvSpPr txBox="1"/>
          <p:nvPr/>
        </p:nvSpPr>
        <p:spPr>
          <a:xfrm>
            <a:off x="-62104" y="-71345"/>
            <a:ext cx="2895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56DE700-7E7B-F247-9A08-D313CB5CF88F}"/>
              </a:ext>
            </a:extLst>
          </p:cNvPr>
          <p:cNvSpPr txBox="1"/>
          <p:nvPr/>
        </p:nvSpPr>
        <p:spPr>
          <a:xfrm>
            <a:off x="3092738" y="4031000"/>
            <a:ext cx="1366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R114G_</a:t>
            </a:r>
            <a:r>
              <a:rPr lang="en-US" sz="1400" kern="0" dirty="0">
                <a:solidFill>
                  <a:srgbClr val="FF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endParaRPr lang="en-US" sz="14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520451D-7517-D45C-8648-5005CA6BC290}"/>
              </a:ext>
            </a:extLst>
          </p:cNvPr>
          <p:cNvSpPr txBox="1"/>
          <p:nvPr/>
        </p:nvSpPr>
        <p:spPr>
          <a:xfrm>
            <a:off x="1794352" y="1765543"/>
            <a:ext cx="104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WT_</a:t>
            </a:r>
            <a:r>
              <a:rPr lang="en-US" sz="1400" kern="0" dirty="0">
                <a:solidFill>
                  <a:srgbClr val="0070C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</a:t>
            </a:r>
            <a:endParaRPr lang="en-US" sz="14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A73869E-B6A9-B971-2167-71A79D688503}"/>
              </a:ext>
            </a:extLst>
          </p:cNvPr>
          <p:cNvSpPr txBox="1"/>
          <p:nvPr/>
        </p:nvSpPr>
        <p:spPr>
          <a:xfrm>
            <a:off x="1815133" y="4031000"/>
            <a:ext cx="1384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R114G_</a:t>
            </a:r>
            <a:r>
              <a:rPr lang="en-US" sz="1400" kern="0" dirty="0">
                <a:solidFill>
                  <a:srgbClr val="FF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</a:t>
            </a:r>
            <a:endParaRPr lang="en-US" sz="14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CA51F18-DA58-1EA9-0D37-9B5005687C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1175" y="2767972"/>
            <a:ext cx="1103955" cy="116309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A05327C-10AE-07CC-248A-076E60B39FFD}"/>
              </a:ext>
            </a:extLst>
          </p:cNvPr>
          <p:cNvSpPr txBox="1"/>
          <p:nvPr/>
        </p:nvSpPr>
        <p:spPr>
          <a:xfrm>
            <a:off x="7606966" y="4031000"/>
            <a:ext cx="1366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R114G_</a:t>
            </a:r>
            <a:r>
              <a:rPr lang="en-US" sz="1400" kern="0" dirty="0">
                <a:solidFill>
                  <a:srgbClr val="0070C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 </a:t>
            </a:r>
            <a:r>
              <a:rPr lang="en-US" sz="1400" kern="0" dirty="0">
                <a:solidFill>
                  <a:srgbClr val="FF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r>
              <a:rPr lang="en-US" sz="1400" kern="0" dirty="0">
                <a:solidFill>
                  <a:srgbClr val="0070C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 </a:t>
            </a:r>
            <a:endParaRPr lang="en-US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107116D-69D0-6944-E449-15BFC05E7870}"/>
              </a:ext>
            </a:extLst>
          </p:cNvPr>
          <p:cNvSpPr txBox="1"/>
          <p:nvPr/>
        </p:nvSpPr>
        <p:spPr>
          <a:xfrm>
            <a:off x="5988924" y="4031000"/>
            <a:ext cx="1384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R114G_</a:t>
            </a:r>
            <a:r>
              <a:rPr lang="en-US" sz="1400" kern="0" dirty="0">
                <a:solidFill>
                  <a:srgbClr val="FF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 </a:t>
            </a:r>
            <a:endParaRPr lang="en-US" sz="14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7B993F5E-FBD8-10D4-7467-9CB40DF984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64203" y="2764512"/>
            <a:ext cx="1325986" cy="118095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A020EA1-ABF9-DBD9-85FA-E49DA60FB9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30482" y="2859769"/>
            <a:ext cx="1145820" cy="110679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FF35BC8-0732-9BD0-F335-D0C84F381C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18171" y="2779436"/>
            <a:ext cx="1675618" cy="126736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F1482E6-982B-20B4-03C3-3F2AE7BA90A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9429" y="2872372"/>
            <a:ext cx="1100536" cy="1052388"/>
          </a:xfrm>
          <a:prstGeom prst="rect">
            <a:avLst/>
          </a:prstGeom>
          <a:solidFill>
            <a:schemeClr val="tx1"/>
          </a:solidFill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6B0E6DE-4F31-5E8B-3692-E316B5E27D0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73605" y="2764144"/>
            <a:ext cx="1331712" cy="133171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F030D07-C8E8-39E1-3CBE-A9C8AD1F1367}"/>
              </a:ext>
            </a:extLst>
          </p:cNvPr>
          <p:cNvSpPr txBox="1"/>
          <p:nvPr/>
        </p:nvSpPr>
        <p:spPr>
          <a:xfrm>
            <a:off x="4451096" y="4031000"/>
            <a:ext cx="1384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R114G_</a:t>
            </a:r>
            <a:r>
              <a:rPr lang="en-US" sz="1400" kern="0" dirty="0">
                <a:solidFill>
                  <a:srgbClr val="FF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</a:t>
            </a:r>
            <a:endParaRPr lang="en-US" sz="1400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53FE7595-3946-0570-B667-D0A2870EB2F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6021" y="779034"/>
            <a:ext cx="1199626" cy="110679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6C8CF1BE-C18D-F66C-5B47-B563ADF0889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32495" y="661947"/>
            <a:ext cx="1308039" cy="121582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9EB9433-AFBF-1788-036B-2AA0733BC74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00940" y="697012"/>
            <a:ext cx="1112869" cy="113713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A158AAE-9C31-5AF5-9AC4-8A195697428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076880" y="653287"/>
            <a:ext cx="1341726" cy="121582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B97F49B-1820-027B-24DF-27B7183DAAA7}"/>
              </a:ext>
            </a:extLst>
          </p:cNvPr>
          <p:cNvSpPr txBox="1"/>
          <p:nvPr/>
        </p:nvSpPr>
        <p:spPr>
          <a:xfrm>
            <a:off x="4689772" y="1792505"/>
            <a:ext cx="104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WT_</a:t>
            </a:r>
            <a:r>
              <a:rPr lang="en-US" sz="1400" kern="0" dirty="0">
                <a:solidFill>
                  <a:srgbClr val="0070C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</a:t>
            </a:r>
            <a:endParaRPr lang="en-US" sz="1400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8119120D-8AC0-50CE-5490-F8B86A1A77A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239843" y="716452"/>
            <a:ext cx="1121951" cy="1157682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9404CF8-8EB3-52B6-F87D-877746EFEDD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589413" y="611483"/>
            <a:ext cx="1204446" cy="1278113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56EE33C-F7B1-1AC1-BA3D-9FF952C3CDBD}"/>
              </a:ext>
            </a:extLst>
          </p:cNvPr>
          <p:cNvSpPr txBox="1"/>
          <p:nvPr/>
        </p:nvSpPr>
        <p:spPr>
          <a:xfrm>
            <a:off x="293293" y="1490715"/>
            <a:ext cx="20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67A262D-A33E-45FD-6E19-C6465434972C}"/>
              </a:ext>
            </a:extLst>
          </p:cNvPr>
          <p:cNvSpPr txBox="1"/>
          <p:nvPr/>
        </p:nvSpPr>
        <p:spPr>
          <a:xfrm>
            <a:off x="293293" y="715692"/>
            <a:ext cx="20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2326132-5D96-5DD7-0BCB-71D65E4FACCF}"/>
              </a:ext>
            </a:extLst>
          </p:cNvPr>
          <p:cNvSpPr txBox="1"/>
          <p:nvPr/>
        </p:nvSpPr>
        <p:spPr>
          <a:xfrm>
            <a:off x="1564859" y="715698"/>
            <a:ext cx="20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8231302-8E30-67B6-8514-E8B069923756}"/>
              </a:ext>
            </a:extLst>
          </p:cNvPr>
          <p:cNvSpPr txBox="1"/>
          <p:nvPr/>
        </p:nvSpPr>
        <p:spPr>
          <a:xfrm>
            <a:off x="1556233" y="1447591"/>
            <a:ext cx="20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B7DC5C1-0E39-AC3D-52D9-B585CD14DBFF}"/>
              </a:ext>
            </a:extLst>
          </p:cNvPr>
          <p:cNvSpPr txBox="1"/>
          <p:nvPr/>
        </p:nvSpPr>
        <p:spPr>
          <a:xfrm>
            <a:off x="3099935" y="1747959"/>
            <a:ext cx="11996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WT_</a:t>
            </a:r>
            <a:r>
              <a:rPr lang="en-US" sz="1400" kern="0" dirty="0">
                <a:solidFill>
                  <a:srgbClr val="0070C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endParaRPr lang="en-US"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D59C480-3996-3B9D-AE2E-3E909BE0F40F}"/>
              </a:ext>
            </a:extLst>
          </p:cNvPr>
          <p:cNvSpPr txBox="1"/>
          <p:nvPr/>
        </p:nvSpPr>
        <p:spPr>
          <a:xfrm>
            <a:off x="398491" y="1803829"/>
            <a:ext cx="104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WT_</a:t>
            </a:r>
            <a:r>
              <a:rPr lang="en-US" sz="1400" kern="0" dirty="0">
                <a:solidFill>
                  <a:srgbClr val="0070C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endParaRPr lang="en-US"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2CBF7CF-EFAC-094C-348D-066EF1570A90}"/>
              </a:ext>
            </a:extLst>
          </p:cNvPr>
          <p:cNvSpPr txBox="1"/>
          <p:nvPr/>
        </p:nvSpPr>
        <p:spPr>
          <a:xfrm>
            <a:off x="7673793" y="1765543"/>
            <a:ext cx="11996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WT_</a:t>
            </a:r>
            <a:r>
              <a:rPr lang="en-US" sz="1400" kern="0" dirty="0">
                <a:solidFill>
                  <a:srgbClr val="0070C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 </a:t>
            </a:r>
            <a:endParaRPr lang="en-US"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A8C6557-733C-0F9A-0D76-7CD15607407F}"/>
              </a:ext>
            </a:extLst>
          </p:cNvPr>
          <p:cNvSpPr txBox="1"/>
          <p:nvPr/>
        </p:nvSpPr>
        <p:spPr>
          <a:xfrm>
            <a:off x="534829" y="4031000"/>
            <a:ext cx="1384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R114G_</a:t>
            </a:r>
            <a:r>
              <a:rPr lang="en-US" sz="1400" kern="0" dirty="0">
                <a:solidFill>
                  <a:srgbClr val="0070C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kern="0" dirty="0">
                <a:solidFill>
                  <a:srgbClr val="FF000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 </a:t>
            </a:r>
            <a:endParaRPr lang="en-US" sz="1400" dirty="0">
              <a:solidFill>
                <a:srgbClr val="FF000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D636527-E95F-DCAD-F14E-37473E7AD63F}"/>
              </a:ext>
            </a:extLst>
          </p:cNvPr>
          <p:cNvSpPr txBox="1"/>
          <p:nvPr/>
        </p:nvSpPr>
        <p:spPr>
          <a:xfrm>
            <a:off x="4180785" y="64540"/>
            <a:ext cx="7826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rgbClr val="3333FF"/>
                </a:solidFill>
              </a:rPr>
              <a:t>W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75B9849-B934-F053-BB89-AABB7E463E5B}"/>
              </a:ext>
            </a:extLst>
          </p:cNvPr>
          <p:cNvSpPr txBox="1"/>
          <p:nvPr/>
        </p:nvSpPr>
        <p:spPr>
          <a:xfrm>
            <a:off x="4011732" y="2152052"/>
            <a:ext cx="12178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rgbClr val="FF0000"/>
                </a:solidFill>
              </a:rPr>
              <a:t>R114G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1A1374C-117F-25B8-6C0B-04878362B93B}"/>
              </a:ext>
            </a:extLst>
          </p:cNvPr>
          <p:cNvSpPr txBox="1"/>
          <p:nvPr/>
        </p:nvSpPr>
        <p:spPr>
          <a:xfrm>
            <a:off x="2054214" y="123505"/>
            <a:ext cx="7826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1 n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9216284-82FB-3CEF-3F8C-315F82D5E55F}"/>
              </a:ext>
            </a:extLst>
          </p:cNvPr>
          <p:cNvSpPr txBox="1"/>
          <p:nvPr/>
        </p:nvSpPr>
        <p:spPr>
          <a:xfrm>
            <a:off x="6280936" y="86775"/>
            <a:ext cx="8638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3 </a:t>
            </a:r>
            <a:r>
              <a:rPr lang="el-GR" sz="2400" b="1" dirty="0"/>
              <a:t>μ</a:t>
            </a:r>
            <a:r>
              <a:rPr lang="en-US" sz="2400" b="1" dirty="0"/>
              <a:t>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4727706-8905-A258-7ACA-66A136E5C172}"/>
              </a:ext>
            </a:extLst>
          </p:cNvPr>
          <p:cNvSpPr txBox="1"/>
          <p:nvPr/>
        </p:nvSpPr>
        <p:spPr>
          <a:xfrm>
            <a:off x="6100252" y="1765543"/>
            <a:ext cx="104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WT_</a:t>
            </a:r>
            <a:r>
              <a:rPr lang="en-US" sz="1400" kern="0" dirty="0">
                <a:solidFill>
                  <a:srgbClr val="0070C0"/>
                </a:solidFill>
                <a:effectLst/>
                <a:latin typeface="Georgia" panose="02040502050405020303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 </a:t>
            </a:r>
            <a:endParaRPr lang="en-US" sz="1400" dirty="0"/>
          </a:p>
        </p:txBody>
      </p:sp>
      <p:sp>
        <p:nvSpPr>
          <p:cNvPr id="35" name="Right Bracket 34">
            <a:extLst>
              <a:ext uri="{FF2B5EF4-FFF2-40B4-BE49-F238E27FC236}">
                <a16:creationId xmlns:a16="http://schemas.microsoft.com/office/drawing/2014/main" id="{4EACEA9E-C3B6-BFCA-432C-1F02B161F661}"/>
              </a:ext>
            </a:extLst>
          </p:cNvPr>
          <p:cNvSpPr/>
          <p:nvPr/>
        </p:nvSpPr>
        <p:spPr>
          <a:xfrm rot="16200000">
            <a:off x="2319939" y="-1251564"/>
            <a:ext cx="206745" cy="3710802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ight Bracket 35">
            <a:extLst>
              <a:ext uri="{FF2B5EF4-FFF2-40B4-BE49-F238E27FC236}">
                <a16:creationId xmlns:a16="http://schemas.microsoft.com/office/drawing/2014/main" id="{6CA6D9DA-E46C-450F-8607-B850F3485CB0}"/>
              </a:ext>
            </a:extLst>
          </p:cNvPr>
          <p:cNvSpPr/>
          <p:nvPr/>
        </p:nvSpPr>
        <p:spPr>
          <a:xfrm rot="16200000">
            <a:off x="6586073" y="-1251564"/>
            <a:ext cx="206745" cy="3710802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ight Bracket 36">
            <a:extLst>
              <a:ext uri="{FF2B5EF4-FFF2-40B4-BE49-F238E27FC236}">
                <a16:creationId xmlns:a16="http://schemas.microsoft.com/office/drawing/2014/main" id="{7283A3E1-1BCD-210E-0A9D-E9E15A8362DF}"/>
              </a:ext>
            </a:extLst>
          </p:cNvPr>
          <p:cNvSpPr/>
          <p:nvPr/>
        </p:nvSpPr>
        <p:spPr>
          <a:xfrm rot="16200000">
            <a:off x="2219759" y="729412"/>
            <a:ext cx="226188" cy="3868720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ight Bracket 37">
            <a:extLst>
              <a:ext uri="{FF2B5EF4-FFF2-40B4-BE49-F238E27FC236}">
                <a16:creationId xmlns:a16="http://schemas.microsoft.com/office/drawing/2014/main" id="{F6E0BDC5-7AB2-4640-E6F5-41BC14266896}"/>
              </a:ext>
            </a:extLst>
          </p:cNvPr>
          <p:cNvSpPr/>
          <p:nvPr/>
        </p:nvSpPr>
        <p:spPr>
          <a:xfrm rot="16200000">
            <a:off x="6703530" y="669692"/>
            <a:ext cx="209345" cy="3971316"/>
          </a:xfrm>
          <a:prstGeom prst="righ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EB9F595-CBF7-3B82-36D6-CE251AEF41CB}"/>
              </a:ext>
            </a:extLst>
          </p:cNvPr>
          <p:cNvSpPr txBox="1"/>
          <p:nvPr/>
        </p:nvSpPr>
        <p:spPr>
          <a:xfrm>
            <a:off x="2054214" y="2173715"/>
            <a:ext cx="7826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1 n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F55EEF4-9610-5349-1DD5-AF65287B8DA9}"/>
              </a:ext>
            </a:extLst>
          </p:cNvPr>
          <p:cNvSpPr txBox="1"/>
          <p:nvPr/>
        </p:nvSpPr>
        <p:spPr>
          <a:xfrm>
            <a:off x="6280936" y="2128361"/>
            <a:ext cx="8638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3 </a:t>
            </a:r>
            <a:r>
              <a:rPr lang="el-GR" sz="2400" b="1" dirty="0"/>
              <a:t>μ</a:t>
            </a:r>
            <a:r>
              <a:rPr lang="en-US" sz="2400" b="1" dirty="0"/>
              <a:t>s</a:t>
            </a:r>
          </a:p>
        </p:txBody>
      </p:sp>
      <p:pic>
        <p:nvPicPr>
          <p:cNvPr id="41" name="Picture 2">
            <a:extLst>
              <a:ext uri="{FF2B5EF4-FFF2-40B4-BE49-F238E27FC236}">
                <a16:creationId xmlns:a16="http://schemas.microsoft.com/office/drawing/2014/main" id="{95A24705-0F64-4B46-E40D-3D98E12F79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1188" y="4384565"/>
            <a:ext cx="3287202" cy="24966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250F8797-F4B5-CB34-F5C0-5F2D135CB117}"/>
              </a:ext>
            </a:extLst>
          </p:cNvPr>
          <p:cNvSpPr txBox="1"/>
          <p:nvPr/>
        </p:nvSpPr>
        <p:spPr>
          <a:xfrm>
            <a:off x="17407" y="260328"/>
            <a:ext cx="5174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US" sz="2800" b="1" dirty="0">
                <a:solidFill>
                  <a:prstClr val="black"/>
                </a:solidFill>
              </a:rPr>
              <a:t>A.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D361BEB-7133-691D-D111-8049BDEE1580}"/>
              </a:ext>
            </a:extLst>
          </p:cNvPr>
          <p:cNvSpPr txBox="1"/>
          <p:nvPr/>
        </p:nvSpPr>
        <p:spPr>
          <a:xfrm>
            <a:off x="2806449" y="4698090"/>
            <a:ext cx="5174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US" sz="2800" b="1" dirty="0">
                <a:solidFill>
                  <a:prstClr val="black"/>
                </a:solidFill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803606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954</TotalTime>
  <Words>365</Words>
  <Application>Microsoft Office PowerPoint</Application>
  <PresentationFormat>On-screen Show (4:3)</PresentationFormat>
  <Paragraphs>80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Georgia</vt:lpstr>
      <vt:lpstr>Office Theme</vt:lpstr>
      <vt:lpstr>Microsoft Word 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utsch, Carol</dc:creator>
  <cp:lastModifiedBy>Deutsch, Carol</cp:lastModifiedBy>
  <cp:revision>118</cp:revision>
  <cp:lastPrinted>2024-12-18T20:34:56Z</cp:lastPrinted>
  <dcterms:created xsi:type="dcterms:W3CDTF">2024-07-16T17:40:05Z</dcterms:created>
  <dcterms:modified xsi:type="dcterms:W3CDTF">2025-01-16T20:14:03Z</dcterms:modified>
</cp:coreProperties>
</file>